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39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3786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9201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75714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04670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691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2235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5081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23162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5939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5423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4939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C668A-3986-41E2-9471-3FAE4DEBB26A}" type="datetimeFigureOut">
              <a:rPr lang="en-GB" smtClean="0"/>
              <a:t>29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33F69-EDAD-4A52-969B-4DD1F57F8A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191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048000" y="794818"/>
            <a:ext cx="6096000" cy="5268365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GB" sz="1200" b="1" u="sng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lomerular membrane attack complex in lupus nephritis is not a reliable marker of ongoing C5 activation: Implications for stratifying patients for complement inhibition.</a:t>
            </a:r>
            <a:endParaRPr lang="en-GB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GB" sz="1200" b="1" u="none" strike="noStrike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Hannah R Wilson</a:t>
            </a:r>
            <a:r>
              <a:rPr lang="en-US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Nicholas R. Medjeral-Thomas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Alyssa C. Gilmore</a:t>
            </a:r>
            <a:r>
              <a:rPr lang="en-US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</a:t>
            </a:r>
            <a:r>
              <a:rPr lang="en-US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Pritesh Trivedi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Kathleen Seyb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2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</a:t>
            </a:r>
            <a:r>
              <a:rPr lang="en-GB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Ramin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 Farzaneh-Far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2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Iva Gunnarsson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3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</a:t>
            </a:r>
            <a:r>
              <a:rPr lang="en-GB" sz="1200" dirty="0" err="1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Agneta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 Zickert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3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Thomas D Cairns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Liz Lightstone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, H. Terence Cook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*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 and Matthew C. Pickering</a:t>
            </a: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*</a:t>
            </a:r>
            <a:endParaRPr lang="en-GB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1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Centre for Inflammatory Disease, Imperial College London, United Kingdom; </a:t>
            </a:r>
            <a:endParaRPr lang="en-GB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aseline="300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2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Ra Pharmaceuticals, Massachusetts, USA; </a:t>
            </a:r>
            <a:endParaRPr lang="en-GB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200" baseline="30000" dirty="0"/>
              <a:t>3</a:t>
            </a:r>
            <a:r>
              <a:rPr lang="en-GB" sz="1200" dirty="0"/>
              <a:t>Department of Medicine, Division of Rheumatology, </a:t>
            </a:r>
            <a:r>
              <a:rPr lang="en-GB" sz="1200" dirty="0" err="1"/>
              <a:t>Karolinska</a:t>
            </a:r>
            <a:r>
              <a:rPr lang="en-GB" sz="1200" dirty="0"/>
              <a:t> </a:t>
            </a:r>
            <a:r>
              <a:rPr lang="en-GB" sz="1200" dirty="0" err="1"/>
              <a:t>Institutet</a:t>
            </a:r>
            <a:r>
              <a:rPr lang="en-GB" sz="1200" dirty="0"/>
              <a:t> and Rheumatology, </a:t>
            </a:r>
            <a:r>
              <a:rPr lang="en-GB" sz="1200" dirty="0" err="1"/>
              <a:t>Karolinska</a:t>
            </a:r>
            <a:r>
              <a:rPr lang="en-GB" sz="1200" dirty="0"/>
              <a:t> University Hospital, Stockholm, </a:t>
            </a:r>
            <a:r>
              <a:rPr lang="en-GB" sz="1200" dirty="0" smtClean="0"/>
              <a:t>Sweden</a:t>
            </a: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.</a:t>
            </a:r>
            <a:endParaRPr lang="en-GB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  <a:spcAft>
                <a:spcPts val="0"/>
              </a:spcAft>
              <a:tabLst>
                <a:tab pos="2865755" algn="ctr"/>
                <a:tab pos="5731510" algn="r"/>
              </a:tabLst>
            </a:pPr>
            <a:r>
              <a:rPr lang="en-GB" sz="12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" panose="02020603050405020304" pitchFamily="18" charset="0"/>
              </a:rPr>
              <a:t>*co-Senior authors</a:t>
            </a:r>
            <a:endParaRPr lang="en-GB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GB" sz="1100" dirty="0" smtClean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GB" sz="12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60388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8"/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6" name="Rectangle 11"/>
          <p:cNvSpPr>
            <a:spLocks noChangeArrowheads="1"/>
          </p:cNvSpPr>
          <p:nvPr/>
        </p:nvSpPr>
        <p:spPr bwMode="auto">
          <a:xfrm>
            <a:off x="0" y="45720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7" name="Rectangle 12"/>
          <p:cNvSpPr>
            <a:spLocks noChangeArrowheads="1"/>
          </p:cNvSpPr>
          <p:nvPr/>
        </p:nvSpPr>
        <p:spPr bwMode="auto">
          <a:xfrm>
            <a:off x="0" y="2076450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b="0" i="0" u="none" strike="noStrike" cap="none" normalizeH="0" baseline="0" smtClean="0">
              <a:ln>
                <a:noFill/>
              </a:ln>
              <a:solidFill>
                <a:srgbClr val="000000"/>
              </a:solidFill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0" lang="en-GB" altLang="en-US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Rectangle 13"/>
          <p:cNvSpPr>
            <a:spLocks noChangeArrowheads="1"/>
          </p:cNvSpPr>
          <p:nvPr/>
        </p:nvSpPr>
        <p:spPr bwMode="auto">
          <a:xfrm>
            <a:off x="0" y="5553075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pSp>
        <p:nvGrpSpPr>
          <p:cNvPr id="14" name="Group 13"/>
          <p:cNvGrpSpPr/>
          <p:nvPr/>
        </p:nvGrpSpPr>
        <p:grpSpPr>
          <a:xfrm>
            <a:off x="2306595" y="1569822"/>
            <a:ext cx="6757213" cy="3476625"/>
            <a:chOff x="263611" y="2937303"/>
            <a:chExt cx="6757213" cy="3476625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76239100"/>
                </p:ext>
              </p:extLst>
            </p:nvPr>
          </p:nvGraphicFramePr>
          <p:xfrm>
            <a:off x="263611" y="2937303"/>
            <a:ext cx="3552825" cy="3476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71" name="Prism 7" r:id="rId3" imgW="3553819" imgH="3480889" progId="Prism7.Document">
                    <p:embed/>
                  </p:oleObj>
                </mc:Choice>
                <mc:Fallback>
                  <p:oleObj name="Prism 7" r:id="rId3" imgW="3553819" imgH="3480889" progId="Prism7.Document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63611" y="2937303"/>
                          <a:ext cx="3552825" cy="3476625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3402226" y="4984150"/>
              <a:ext cx="23065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/>
                <a:t>Healthy Control</a:t>
              </a:r>
              <a:endParaRPr lang="en-GB" sz="12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412788" y="3401538"/>
              <a:ext cx="26196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Patient 7</a:t>
              </a:r>
              <a:endParaRPr lang="en-GB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936152" y="4507041"/>
              <a:ext cx="110387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/>
                <a:t>Patient 5</a:t>
              </a:r>
              <a:endParaRPr lang="en-GB" b="1" dirty="0"/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4396816" y="3318924"/>
              <a:ext cx="2624008" cy="1493669"/>
              <a:chOff x="4629661" y="3199044"/>
              <a:chExt cx="2624008" cy="1493669"/>
            </a:xfrm>
          </p:grpSpPr>
          <p:grpSp>
            <p:nvGrpSpPr>
              <p:cNvPr id="12" name="Group 11"/>
              <p:cNvGrpSpPr/>
              <p:nvPr/>
            </p:nvGrpSpPr>
            <p:grpSpPr>
              <a:xfrm>
                <a:off x="5646179" y="3199044"/>
                <a:ext cx="1466336" cy="1493669"/>
                <a:chOff x="1062680" y="584886"/>
                <a:chExt cx="1466336" cy="1493669"/>
              </a:xfrm>
            </p:grpSpPr>
            <p:pic>
              <p:nvPicPr>
                <p:cNvPr id="2051" name="Picture 2" descr="482--05 C5b9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8359" t="14194" r="8050" b="39989"/>
                <a:stretch/>
              </p:blipFill>
              <p:spPr bwMode="auto">
                <a:xfrm>
                  <a:off x="1811766" y="584886"/>
                  <a:ext cx="716693" cy="73316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053" name="Picture 4" descr="8--05 C5b9"/>
                <p:cNvPicPr>
                  <a:picLocks noChangeAspect="1" noChangeArrowheads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10" t="37239" r="59940" b="17771"/>
                <a:stretch/>
              </p:blipFill>
              <p:spPr bwMode="auto">
                <a:xfrm>
                  <a:off x="1804086" y="1351005"/>
                  <a:ext cx="724930" cy="72493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050" name="Picture 1" descr="548--04 C5b9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366" t="7885" r="18106" b="46836"/>
                <a:stretch/>
              </p:blipFill>
              <p:spPr bwMode="auto">
                <a:xfrm>
                  <a:off x="1062680" y="584886"/>
                  <a:ext cx="700217" cy="73316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052" name="Picture 3" descr="203--04 C5b9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7400" t="9875" b="45725"/>
                <a:stretch/>
              </p:blipFill>
              <p:spPr bwMode="auto">
                <a:xfrm>
                  <a:off x="1062680" y="1363147"/>
                  <a:ext cx="700216" cy="71540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16" name="TextBox 15"/>
              <p:cNvSpPr txBox="1"/>
              <p:nvPr/>
            </p:nvSpPr>
            <p:spPr>
              <a:xfrm>
                <a:off x="4629661" y="3352801"/>
                <a:ext cx="1103871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 smtClean="0"/>
                  <a:t>Patient 5</a:t>
                </a:r>
                <a:endParaRPr lang="en-GB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4634037" y="4187695"/>
                <a:ext cx="26196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b="1" dirty="0" smtClean="0"/>
                  <a:t>Patient 7</a:t>
                </a:r>
                <a:endParaRPr lang="en-GB" b="1" dirty="0"/>
              </a:p>
            </p:txBody>
          </p:sp>
        </p:grpSp>
      </p:grpSp>
      <p:cxnSp>
        <p:nvCxnSpPr>
          <p:cNvPr id="21" name="Straight Connector 20"/>
          <p:cNvCxnSpPr/>
          <p:nvPr/>
        </p:nvCxnSpPr>
        <p:spPr>
          <a:xfrm>
            <a:off x="7944368" y="2627714"/>
            <a:ext cx="17067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7944368" y="3383568"/>
            <a:ext cx="17067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8698130" y="2627714"/>
            <a:ext cx="17067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8698130" y="3383568"/>
            <a:ext cx="170671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222422" y="5553075"/>
            <a:ext cx="906985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Figure 1. </a:t>
            </a:r>
            <a:r>
              <a:rPr lang="en-GB" sz="1200" b="1" dirty="0"/>
              <a:t>C5b-9 concentration in the plasma </a:t>
            </a:r>
            <a:r>
              <a:rPr lang="en-GB" sz="1200" b="1" dirty="0" smtClean="0"/>
              <a:t>of patients with serial biopsies, pre and post treatment taken from the time of biopsy with C5b-9 staining from the time of biopsy for comparison. </a:t>
            </a:r>
            <a:r>
              <a:rPr lang="en-GB" sz="1200" dirty="0"/>
              <a:t>C5b-9 plasma concentration was higher in </a:t>
            </a:r>
            <a:r>
              <a:rPr lang="en-GB" sz="1200" dirty="0" smtClean="0"/>
              <a:t>both patients </a:t>
            </a:r>
            <a:r>
              <a:rPr lang="en-GB" sz="1200" dirty="0"/>
              <a:t>pre-treatment compared with post-treatment. </a:t>
            </a:r>
            <a:r>
              <a:rPr lang="en-GB" sz="1200" dirty="0" smtClean="0"/>
              <a:t>In comparison to pre-treatment, C5b-9 staining increased in patient 5 in the post treatment biopsy and decreased in patient 7 in the post treatment biopsy.</a:t>
            </a:r>
            <a:endParaRPr lang="en-GB" sz="1200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88982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112</Words>
  <Application>Microsoft Office PowerPoint</Application>
  <PresentationFormat>Widescreen</PresentationFormat>
  <Paragraphs>1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Times</vt:lpstr>
      <vt:lpstr>Times New Roman</vt:lpstr>
      <vt:lpstr>Office Theme</vt:lpstr>
      <vt:lpstr>Prism 7</vt:lpstr>
      <vt:lpstr>PowerPoint Presentation</vt:lpstr>
      <vt:lpstr>PowerPoint Presentation</vt:lpstr>
    </vt:vector>
  </TitlesOfParts>
  <Company>Imperial College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lson, Hannah R</dc:creator>
  <cp:lastModifiedBy>Wilson, Hannah R</cp:lastModifiedBy>
  <cp:revision>4</cp:revision>
  <dcterms:created xsi:type="dcterms:W3CDTF">2018-08-14T09:45:01Z</dcterms:created>
  <dcterms:modified xsi:type="dcterms:W3CDTF">2018-08-29T13:45:07Z</dcterms:modified>
</cp:coreProperties>
</file>